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3" r:id="rId3"/>
    <p:sldId id="26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76" autoAdjust="0"/>
    <p:restoredTop sz="84987" autoAdjust="0"/>
  </p:normalViewPr>
  <p:slideViewPr>
    <p:cSldViewPr snapToGrid="0">
      <p:cViewPr varScale="1">
        <p:scale>
          <a:sx n="85" d="100"/>
          <a:sy n="85" d="100"/>
        </p:scale>
        <p:origin x="778" y="4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:$K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3.8490017945975077</c:v>
                  </c:pt>
                  <c:pt idx="3">
                    <c:v>7.6980035891950074</c:v>
                  </c:pt>
                  <c:pt idx="4">
                    <c:v>3.8490017945975041</c:v>
                  </c:pt>
                  <c:pt idx="5">
                    <c:v>3.8490017945975006</c:v>
                  </c:pt>
                  <c:pt idx="6">
                    <c:v>0</c:v>
                  </c:pt>
                </c:numCache>
              </c:numRef>
            </c:plus>
            <c:minus>
              <c:numRef>
                <c:f>Sheet1!$E$8:$K$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3.8490017945975077</c:v>
                  </c:pt>
                  <c:pt idx="3">
                    <c:v>7.6980035891950074</c:v>
                  </c:pt>
                  <c:pt idx="4">
                    <c:v>3.8490017945975041</c:v>
                  </c:pt>
                  <c:pt idx="5">
                    <c:v>3.8490017945975006</c:v>
                  </c:pt>
                  <c:pt idx="6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7:$K$7</c:f>
              <c:strCache>
                <c:ptCount val="7"/>
                <c:pt idx="0">
                  <c:v>10^7</c:v>
                </c:pt>
                <c:pt idx="1">
                  <c:v>10^6</c:v>
                </c:pt>
                <c:pt idx="2">
                  <c:v>10^5</c:v>
                </c:pt>
                <c:pt idx="3">
                  <c:v>10^4</c:v>
                </c:pt>
                <c:pt idx="4">
                  <c:v>10^3</c:v>
                </c:pt>
                <c:pt idx="5">
                  <c:v>10^2</c:v>
                </c:pt>
                <c:pt idx="6">
                  <c:v>Control</c:v>
                </c:pt>
              </c:strCache>
            </c:strRef>
          </c:cat>
          <c:val>
            <c:numRef>
              <c:f>Sheet1!$E$9:$K$9</c:f>
              <c:numCache>
                <c:formatCode>General</c:formatCode>
                <c:ptCount val="7"/>
                <c:pt idx="0">
                  <c:v>100</c:v>
                </c:pt>
                <c:pt idx="1">
                  <c:v>100</c:v>
                </c:pt>
                <c:pt idx="2">
                  <c:v>82.222222222222229</c:v>
                </c:pt>
                <c:pt idx="3">
                  <c:v>68.888888888888886</c:v>
                </c:pt>
                <c:pt idx="4">
                  <c:v>55.555555555555564</c:v>
                </c:pt>
                <c:pt idx="5">
                  <c:v>22.222222222222225</c:v>
                </c:pt>
                <c:pt idx="6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956-4D91-ADC6-99AD6CD8AD4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07464479"/>
        <c:axId val="1307462399"/>
      </c:barChart>
      <c:catAx>
        <c:axId val="13074644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xperimental groups (CFU/Fish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307462399"/>
        <c:crosses val="autoZero"/>
        <c:auto val="1"/>
        <c:lblAlgn val="ctr"/>
        <c:lblOffset val="100"/>
        <c:noMultiLvlLbl val="0"/>
      </c:catAx>
      <c:valAx>
        <c:axId val="1307462399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4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inal cumulative mortality (%) at day 14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3074644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89A749-39CA-479E-8112-A357F190B0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D1A9B90-9969-47F8-97BB-4A6EDDAD6FB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0E29E-9660-47D4-9864-D4C3D602B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86CD34-D98C-4CB9-B0FB-9A90BC6A3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B01AF8-ECC9-42D2-9016-3432A05ED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6796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90F541-DF27-4F9C-AADE-FE72F8987E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295E22-E5DB-4BEA-9B26-1496F1B225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034B3D-1450-4344-A00D-7426E605D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2FAB4C-AEA2-48B7-83B7-EEBEBE665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136EE-5230-49B2-99C1-1E3272386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249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3D80F3A-01D6-41A7-A5AB-7EE9C01A90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B00E61-0430-44FA-BF02-A35A26BE38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AB1553-DF82-4F9D-B4C1-6651E9747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4A4B78-C79B-4DCD-B56E-FDB9F82BDE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44EA32-D7E3-4F9A-8BA6-77412F27B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171A0-4B69-4441-8499-1AA303747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0B4FEF-4E83-4ABB-A94A-108B48BC2A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17DF53-CA66-48AC-AA1E-514DAD09E0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81016-1FC6-4AD1-88CC-AE1732DBE5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F69CEC-854E-4F80-AA75-46E3BA35F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0853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5A3082-5D49-47B1-BFF0-297BE061CB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D4FB7F-23BB-4C4C-ABC3-EC9A8048FA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6D4B3C-B6CF-4361-8117-39A229F82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A6EB92-3D9C-41A3-B1F4-603ABA12D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2CC847-C97A-4FE3-84CE-1D81DDFDF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8138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EF543C-D47E-41C2-9B20-2F8D8CCEB8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BA681F-7CCE-4B40-B4FE-CF61C56A1BC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6C405A-E7D0-448E-AF43-10E1C3E8A7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CAF055-21BA-414B-962E-7E2182481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69128C-393C-4D8A-BB3E-DE72F4981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092D34-93C3-40F6-9706-17879DBC6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57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6BB3A8-B88D-4DD4-AEAF-3B7E3E05B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B3D914-FA84-480C-83DF-78927A1F538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82339F-18BE-4325-A1BC-B3D65690EC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7481FB5-0D47-459E-9560-DC11FD9629C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DA7150C-E68C-4EF0-AE12-67F757A2B1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41D715-1D85-469F-8517-8DD73E369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46F8CCA-7994-4773-87A6-12A1AEA26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E0FAAC-6F34-41C7-A39B-946B4EC751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654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2A1380-CC49-45E4-98A0-1455A8EA8B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369BAE-418E-4491-943E-095FA455B2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91CB6D6-9084-4FE7-8571-712281E9B0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20DA819-851F-4ED1-9591-56F2B33D5A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21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2B7657B-38DB-4436-AC2B-454A92BE9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C140C9-FA9B-48F1-89FC-C90FC7532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6A26615-4D32-4E54-A19E-4841F98AA5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843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7878DB-2F1A-4D38-8D75-5CBF97A511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B170AC-363C-4266-8809-7EC9BDB7EE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41A8A0-47D2-423A-8A01-3DEA4939B4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751D4C-EEC9-4460-BD4D-A99EDB1264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DE4807-F435-42A0-ABBD-09449A95D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2864AA-F643-4C56-882F-EFE0BF2C2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792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A16289-B045-405A-B6B1-BCB60F126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0974725-E909-4392-94A4-4BC01975794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E063F5-6105-4C0F-81D3-1F803B396C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D4F0E5-1A0F-4182-A9AF-4287F7BA8B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AB949FB-3118-4275-9EB4-A6D5F4CA6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5CC42B-4CCE-4CE1-BDB2-02E8F3316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780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E1C23FC-8096-4876-8417-EB7157895F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3C3DCC-E577-445D-AB5B-4616888F28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89B23A-9EBF-4410-B8C5-C9C00523BD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DA784-25D5-4E5B-BFF7-8015008E38BB}" type="datetimeFigureOut">
              <a:rPr lang="en-US" smtClean="0"/>
              <a:t>6/20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89EA81-D357-468F-B110-09AC9AC248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38F0AA-E2F3-4445-BFC6-1864E71B24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0CE0D-E9E8-434D-858F-83D27C797A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4622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7632/8c7swfyy9z.1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364C87F6-E25E-45F1-BE4A-85949507C5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130310" y="1148080"/>
            <a:ext cx="3741297" cy="480568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BD92F64-326D-4A6F-9984-A1E7CE133B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23395" y="254000"/>
            <a:ext cx="3130384" cy="220472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F3B3925A-61FB-4155-8CD8-63B073AE2B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23395" y="2458720"/>
            <a:ext cx="3130384" cy="22047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4C753A2E-000E-43E2-9A8E-A187CE02F1F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3395" y="4663439"/>
            <a:ext cx="3130384" cy="2204719"/>
          </a:xfrm>
          <a:prstGeom prst="rect">
            <a:avLst/>
          </a:prstGeom>
        </p:spPr>
      </p:pic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2378C263-7E0C-4BD2-8E7A-72DD8F7C701E}"/>
              </a:ext>
            </a:extLst>
          </p:cNvPr>
          <p:cNvCxnSpPr>
            <a:cxnSpLocks/>
            <a:endCxn id="7" idx="1"/>
          </p:cNvCxnSpPr>
          <p:nvPr/>
        </p:nvCxnSpPr>
        <p:spPr>
          <a:xfrm flipV="1">
            <a:off x="2936240" y="1356360"/>
            <a:ext cx="2487155" cy="6146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FD3F101A-8F4C-43C5-9D49-D3C4DA6F8C04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2712720" y="2179320"/>
            <a:ext cx="2710675" cy="13817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F2D05E49-A637-4E86-9597-F80AA9B606DC}"/>
              </a:ext>
            </a:extLst>
          </p:cNvPr>
          <p:cNvCxnSpPr>
            <a:cxnSpLocks/>
          </p:cNvCxnSpPr>
          <p:nvPr/>
        </p:nvCxnSpPr>
        <p:spPr>
          <a:xfrm>
            <a:off x="2936240" y="3413761"/>
            <a:ext cx="2570480" cy="248412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FA7424A2-D69C-4FC1-BED7-E8D2946D8179}"/>
              </a:ext>
            </a:extLst>
          </p:cNvPr>
          <p:cNvSpPr txBox="1"/>
          <p:nvPr/>
        </p:nvSpPr>
        <p:spPr>
          <a:xfrm>
            <a:off x="197224" y="125506"/>
            <a:ext cx="1972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 S1</a:t>
            </a:r>
          </a:p>
        </p:txBody>
      </p:sp>
    </p:spTree>
    <p:extLst>
      <p:ext uri="{BB962C8B-B14F-4D97-AF65-F5344CB8AC3E}">
        <p14:creationId xmlns:p14="http://schemas.microsoft.com/office/powerpoint/2010/main" val="3203507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897D5E43-1B69-4554-8E43-01739436CBC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03802039"/>
              </p:ext>
            </p:extLst>
          </p:nvPr>
        </p:nvGraphicFramePr>
        <p:xfrm>
          <a:off x="995604" y="696158"/>
          <a:ext cx="9672395" cy="53287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51F1D46C-2E93-408A-A1C5-20A75625E1BC}"/>
              </a:ext>
            </a:extLst>
          </p:cNvPr>
          <p:cNvSpPr txBox="1"/>
          <p:nvPr/>
        </p:nvSpPr>
        <p:spPr>
          <a:xfrm>
            <a:off x="2296160" y="51149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6CEA173-0CB6-40F8-8DE5-1F36150645A6}"/>
              </a:ext>
            </a:extLst>
          </p:cNvPr>
          <p:cNvSpPr txBox="1"/>
          <p:nvPr/>
        </p:nvSpPr>
        <p:spPr>
          <a:xfrm>
            <a:off x="3525520" y="51149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F66A26A-BB37-4B25-90AA-3861F57C3E3D}"/>
              </a:ext>
            </a:extLst>
          </p:cNvPr>
          <p:cNvSpPr txBox="1"/>
          <p:nvPr/>
        </p:nvSpPr>
        <p:spPr>
          <a:xfrm>
            <a:off x="4754880" y="116173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94A263-FAC1-417D-A08C-EE691AFDE891}"/>
              </a:ext>
            </a:extLst>
          </p:cNvPr>
          <p:cNvSpPr txBox="1"/>
          <p:nvPr/>
        </p:nvSpPr>
        <p:spPr>
          <a:xfrm>
            <a:off x="5963920" y="1608772"/>
            <a:ext cx="436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b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D334BA8-13DC-4AC9-9F1B-64FB89151789}"/>
              </a:ext>
            </a:extLst>
          </p:cNvPr>
          <p:cNvSpPr txBox="1"/>
          <p:nvPr/>
        </p:nvSpPr>
        <p:spPr>
          <a:xfrm>
            <a:off x="7244080" y="234029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c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82F9E5-0F1D-4C1E-9369-88DEF63EE544}"/>
              </a:ext>
            </a:extLst>
          </p:cNvPr>
          <p:cNvSpPr txBox="1"/>
          <p:nvPr/>
        </p:nvSpPr>
        <p:spPr>
          <a:xfrm>
            <a:off x="8473440" y="382365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4F07932-918F-4302-94B8-7574DF0049B4}"/>
              </a:ext>
            </a:extLst>
          </p:cNvPr>
          <p:cNvSpPr txBox="1"/>
          <p:nvPr/>
        </p:nvSpPr>
        <p:spPr>
          <a:xfrm>
            <a:off x="9702800" y="4981892"/>
            <a:ext cx="3657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DA940BC-108D-488B-AAE3-0CA57C41FF45}"/>
              </a:ext>
            </a:extLst>
          </p:cNvPr>
          <p:cNvSpPr txBox="1"/>
          <p:nvPr/>
        </p:nvSpPr>
        <p:spPr>
          <a:xfrm>
            <a:off x="197224" y="125506"/>
            <a:ext cx="19722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ig S2</a:t>
            </a:r>
          </a:p>
        </p:txBody>
      </p:sp>
    </p:spTree>
    <p:extLst>
      <p:ext uri="{BB962C8B-B14F-4D97-AF65-F5344CB8AC3E}">
        <p14:creationId xmlns:p14="http://schemas.microsoft.com/office/powerpoint/2010/main" val="4105414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381C80-2C43-47BA-ADD2-232E83FF03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87188" y="1458819"/>
            <a:ext cx="10515600" cy="1325563"/>
          </a:xfrm>
        </p:spPr>
        <p:txBody>
          <a:bodyPr>
            <a:normAutofit fontScale="90000"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deo S1 </a:t>
            </a:r>
            <a:b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US" sz="18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supplementary video (Video S1) is available in Mendeley Data at </a:t>
            </a:r>
            <a:r>
              <a:rPr lang="en-US" sz="1800" u="sng">
                <a:solidFill>
                  <a:srgbClr val="0563C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https://doi.org/10.17632/8c7swfyy9z.1</a:t>
            </a:r>
            <a:r>
              <a:rPr lang="en-US" sz="18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br>
              <a:rPr lang="en-US" sz="18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7072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89</TotalTime>
  <Words>51</Words>
  <Application>Microsoft Office PowerPoint</Application>
  <PresentationFormat>Widescreen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Video S1  The supplementary video (Video S1) is available in Mendeley Data at https://doi.org/10.17632/8c7swfyy9z.1 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DH</dc:creator>
  <cp:lastModifiedBy>TDH</cp:lastModifiedBy>
  <cp:revision>32</cp:revision>
  <dcterms:created xsi:type="dcterms:W3CDTF">2026-01-20T02:23:31Z</dcterms:created>
  <dcterms:modified xsi:type="dcterms:W3CDTF">2026-06-20T16:30:23Z</dcterms:modified>
</cp:coreProperties>
</file>